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7" d="100"/>
          <a:sy n="107" d="100"/>
        </p:scale>
        <p:origin x="-84" y="-3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4" Type="http://schemas.openxmlformats.org/officeDocument/2006/relationships/image" Target="../media/image4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118424-7749-A846-B0D1-B182C3256B90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1B81B-64EC-074D-8A2F-DFB076867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76871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118424-7749-A846-B0D1-B182C3256B90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1B81B-64EC-074D-8A2F-DFB076867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99881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118424-7749-A846-B0D1-B182C3256B90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1B81B-64EC-074D-8A2F-DFB076867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10487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118424-7749-A846-B0D1-B182C3256B90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1B81B-64EC-074D-8A2F-DFB076867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20590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118424-7749-A846-B0D1-B182C3256B90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1B81B-64EC-074D-8A2F-DFB076867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33359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118424-7749-A846-B0D1-B182C3256B90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1B81B-64EC-074D-8A2F-DFB076867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59306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118424-7749-A846-B0D1-B182C3256B90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1B81B-64EC-074D-8A2F-DFB076867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59027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118424-7749-A846-B0D1-B182C3256B90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1B81B-64EC-074D-8A2F-DFB076867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77608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118424-7749-A846-B0D1-B182C3256B90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1B81B-64EC-074D-8A2F-DFB076867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94074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118424-7749-A846-B0D1-B182C3256B90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1B81B-64EC-074D-8A2F-DFB076867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8897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118424-7749-A846-B0D1-B182C3256B90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A1B81B-64EC-074D-8A2F-DFB076867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33271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118424-7749-A846-B0D1-B182C3256B90}" type="datetimeFigureOut">
              <a:rPr lang="en-US" smtClean="0"/>
              <a:t>7/3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A1B81B-64EC-074D-8A2F-DFB0768676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31518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w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wmf"/><Relationship Id="rId4" Type="http://schemas.openxmlformats.org/officeDocument/2006/relationships/image" Target="../media/image1.wmf"/><Relationship Id="rId9" Type="http://schemas.openxmlformats.org/officeDocument/2006/relationships/oleObject" Target="../embeddings/oleObject4.bin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43993066"/>
              </p:ext>
            </p:extLst>
          </p:nvPr>
        </p:nvGraphicFramePr>
        <p:xfrm>
          <a:off x="39709" y="2306723"/>
          <a:ext cx="2589577" cy="268909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" name="Graph" r:id="rId3" imgW="3718080" imgH="2895840" progId="Origin50.Graph">
                  <p:embed/>
                </p:oleObj>
              </mc:Choice>
              <mc:Fallback>
                <p:oleObj name="Graph" r:id="rId3" imgW="3718080" imgH="289584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9709" y="2306723"/>
                        <a:ext cx="2589577" cy="268909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83752125"/>
              </p:ext>
            </p:extLst>
          </p:nvPr>
        </p:nvGraphicFramePr>
        <p:xfrm>
          <a:off x="2312038" y="2306723"/>
          <a:ext cx="2594868" cy="26945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0" name="Graph" r:id="rId5" imgW="3718080" imgH="2895840" progId="Origin50.Graph">
                  <p:embed/>
                </p:oleObj>
              </mc:Choice>
              <mc:Fallback>
                <p:oleObj name="Graph" r:id="rId5" imgW="3718080" imgH="289584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312038" y="2306723"/>
                        <a:ext cx="2594868" cy="269458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69716126"/>
              </p:ext>
            </p:extLst>
          </p:nvPr>
        </p:nvGraphicFramePr>
        <p:xfrm>
          <a:off x="4480281" y="2312217"/>
          <a:ext cx="2589576" cy="26890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1" name="Graph" r:id="rId7" imgW="3718080" imgH="2895840" progId="Origin50.Graph">
                  <p:embed/>
                </p:oleObj>
              </mc:Choice>
              <mc:Fallback>
                <p:oleObj name="Graph" r:id="rId7" imgW="3718080" imgH="289584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480281" y="2312217"/>
                        <a:ext cx="2589576" cy="268909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73723215"/>
              </p:ext>
            </p:extLst>
          </p:nvPr>
        </p:nvGraphicFramePr>
        <p:xfrm>
          <a:off x="6648524" y="2312217"/>
          <a:ext cx="2589576" cy="26890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2" name="Graph" r:id="rId9" imgW="3718080" imgH="2895840" progId="Origin50.Graph">
                  <p:embed/>
                </p:oleObj>
              </mc:Choice>
              <mc:Fallback>
                <p:oleObj name="Graph" r:id="rId9" imgW="3718080" imgH="289584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6648524" y="2312217"/>
                        <a:ext cx="2589576" cy="268909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409887" y="2190080"/>
            <a:ext cx="20855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pontaneous fusion</a:t>
            </a:r>
            <a:endParaRPr lang="en-US" b="1" dirty="0"/>
          </a:p>
        </p:txBody>
      </p:sp>
      <p:sp>
        <p:nvSpPr>
          <p:cNvPr id="9" name="TextBox 8"/>
          <p:cNvSpPr txBox="1"/>
          <p:nvPr/>
        </p:nvSpPr>
        <p:spPr>
          <a:xfrm>
            <a:off x="746554" y="1609017"/>
            <a:ext cx="13542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NAREs only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2901778" y="1609017"/>
            <a:ext cx="14670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NAREs + </a:t>
            </a:r>
            <a:r>
              <a:rPr lang="en-US" dirty="0" err="1" smtClean="0"/>
              <a:t>Cpx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5073786" y="1609017"/>
            <a:ext cx="15258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NAREs + Syt1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7000953" y="1606832"/>
            <a:ext cx="20954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NAREs + Syt1 + </a:t>
            </a:r>
            <a:r>
              <a:rPr lang="en-US" dirty="0" err="1" smtClean="0"/>
              <a:t>Cpx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457363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731191098"/>
              </p:ext>
            </p:extLst>
          </p:nvPr>
        </p:nvGraphicFramePr>
        <p:xfrm>
          <a:off x="905528" y="2485447"/>
          <a:ext cx="7261933" cy="18542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883642"/>
                <a:gridCol w="2214105"/>
                <a:gridCol w="2420644"/>
                <a:gridCol w="743542"/>
              </a:tblGrid>
              <a:tr h="370840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 smtClean="0"/>
                        <a:t>Spontaneous events</a:t>
                      </a:r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dirty="0" smtClean="0"/>
                        <a:t>Total</a:t>
                      </a:r>
                      <a:r>
                        <a:rPr lang="en-US" baseline="0" dirty="0" smtClean="0"/>
                        <a:t> analyzed events</a:t>
                      </a:r>
                      <a:endParaRPr lang="en-US" dirty="0" smtClean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N</a:t>
                      </a:r>
                      <a:endParaRPr lang="en-US" dirty="0"/>
                    </a:p>
                  </a:txBody>
                  <a:tcPr marL="68580" marR="68580"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 smtClean="0"/>
                        <a:t>SNARE only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89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1857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 marL="68580" marR="68580"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 smtClean="0"/>
                        <a:t>SNARE/</a:t>
                      </a:r>
                      <a:r>
                        <a:rPr lang="en-US" dirty="0" err="1" smtClean="0"/>
                        <a:t>Cpx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77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2713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 marL="68580" marR="68580"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 smtClean="0"/>
                        <a:t>SNARE/Syt1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147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2982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 marL="68580" marR="68580"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 smtClean="0"/>
                        <a:t>SNARE/Syt1/</a:t>
                      </a:r>
                      <a:r>
                        <a:rPr lang="en-US" dirty="0" err="1" smtClean="0"/>
                        <a:t>Cpx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75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2765</a:t>
                      </a:r>
                      <a:endParaRPr lang="en-US" dirty="0"/>
                    </a:p>
                  </a:txBody>
                  <a:tcPr marL="68580" marR="6858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4</a:t>
                      </a:r>
                      <a:endParaRPr lang="en-US" dirty="0"/>
                    </a:p>
                  </a:txBody>
                  <a:tcPr marL="68580" marR="68580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237439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8</Words>
  <Application>Microsoft Office PowerPoint</Application>
  <PresentationFormat>On-screen Show (4:3)</PresentationFormat>
  <Paragraphs>24</Paragraphs>
  <Slides>2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4" baseType="lpstr">
      <vt:lpstr>Office Theme</vt:lpstr>
      <vt:lpstr>Graph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xel Brunger</dc:creator>
  <cp:lastModifiedBy>Diao</cp:lastModifiedBy>
  <cp:revision>2</cp:revision>
  <dcterms:created xsi:type="dcterms:W3CDTF">2014-07-31T20:12:59Z</dcterms:created>
  <dcterms:modified xsi:type="dcterms:W3CDTF">2014-07-31T20:23:48Z</dcterms:modified>
</cp:coreProperties>
</file>